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8"/>
  </p:notesMasterIdLst>
  <p:sldIdLst>
    <p:sldId id="274" r:id="rId2"/>
    <p:sldId id="265" r:id="rId3"/>
    <p:sldId id="259" r:id="rId4"/>
    <p:sldId id="266" r:id="rId5"/>
    <p:sldId id="261" r:id="rId6"/>
    <p:sldId id="278" r:id="rId7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ile medio 2 - Colore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E25E649-3F16-4E02-A733-19D2CDBF48F0}" styleName="Stile medio 3 - Colore 1">
    <a:wholeTbl>
      <a:tcTxStyle>
        <a:fontRef idx="minor">
          <a:scrgbClr r="0" g="0" b="0"/>
        </a:fontRef>
        <a:schemeClr val="dk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25400" cmpd="sng">
              <a:solidFill>
                <a:schemeClr val="dk1"/>
              </a:solidFill>
            </a:ln>
          </a:top>
          <a:bottom>
            <a:ln w="25400" cmpd="sng">
              <a:solidFill>
                <a:schemeClr val="dk1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lt1"/>
          </a:solidFill>
        </a:fill>
      </a:tcStyle>
    </a:wholeTbl>
    <a:band1H>
      <a:tcStyle>
        <a:tcBdr/>
        <a:fill>
          <a:solidFill>
            <a:schemeClr val="dk1">
              <a:tint val="20000"/>
            </a:schemeClr>
          </a:solidFill>
        </a:fill>
      </a:tcStyle>
    </a:band1H>
    <a:band1V>
      <a:tcStyle>
        <a:tcBdr/>
        <a:fill>
          <a:solidFill>
            <a:schemeClr val="dk1">
              <a:tint val="20000"/>
            </a:schemeClr>
          </a:solidFill>
        </a:fill>
      </a:tcStyle>
    </a:band1V>
    <a:la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scrgbClr r="0" g="0" b="0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/>
      <a:tcStyle>
        <a:tcBdr>
          <a:top>
            <a:ln w="50800" cmpd="dbl">
              <a:solidFill>
                <a:schemeClr val="dk1"/>
              </a:solidFill>
            </a:ln>
          </a:top>
        </a:tcBdr>
        <a:fill>
          <a:solidFill>
            <a:schemeClr val="lt1"/>
          </a:solidFill>
        </a:fill>
      </a:tcStyle>
    </a:lastRow>
    <a:seCell>
      <a:tcTxStyle b="on">
        <a:fontRef idx="minor">
          <a:scrgbClr r="0" g="0" b="0"/>
        </a:fontRef>
        <a:schemeClr val="dk1"/>
      </a:tcTxStyle>
      <a:tcStyle>
        <a:tcBdr/>
      </a:tcStyle>
    </a:seCell>
    <a:swCell>
      <a:tcTxStyle b="on">
        <a:fontRef idx="minor">
          <a:scrgbClr r="0" g="0" b="0"/>
        </a:fontRef>
        <a:schemeClr val="dk1"/>
      </a:tcTxStyle>
      <a:tcStyle>
        <a:tcBdr/>
      </a:tcStyle>
    </a:swCell>
    <a:firstRow>
      <a:tcTxStyle b="on">
        <a:fontRef idx="minor">
          <a:scrgbClr r="0" g="0" b="0"/>
        </a:fontRef>
        <a:schemeClr val="lt1"/>
      </a:tcTxStyle>
      <a:tcStyle>
        <a:tcBdr>
          <a:bottom>
            <a:ln w="25400" cmpd="sng">
              <a:solidFill>
                <a:schemeClr val="dk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2D5ABB26-0587-4C30-8999-92F81FD0307C}" styleName="Nessuno stile, nessuna griglia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  <a:tblStyle styleId="{C083E6E3-FA7D-4D7B-A595-EF9225AFEA82}" styleName="Stile chiaro 1 - Colore 3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 w="12700" cmpd="sng">
              <a:solidFill>
                <a:schemeClr val="accent3"/>
              </a:solidFill>
            </a:ln>
          </a:top>
          <a:bottom>
            <a:ln w="12700" cmpd="sng">
              <a:solidFill>
                <a:schemeClr val="accent3"/>
              </a:solidFill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3">
              <a:alpha val="2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3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12700" cmpd="sng">
              <a:solidFill>
                <a:schemeClr val="accent3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12700" cmpd="sng">
              <a:solidFill>
                <a:schemeClr val="accent3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237" autoAdjust="0"/>
    <p:restoredTop sz="94660"/>
  </p:normalViewPr>
  <p:slideViewPr>
    <p:cSldViewPr snapToGrid="0">
      <p:cViewPr varScale="1">
        <p:scale>
          <a:sx n="113" d="100"/>
          <a:sy n="113" d="100"/>
        </p:scale>
        <p:origin x="1568" y="1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74BC76-80F2-4193-8A16-9A25FE9B7922}" type="datetimeFigureOut">
              <a:rPr lang="en-US" smtClean="0"/>
              <a:t>4/9/21</a:t>
            </a:fld>
            <a:endParaRPr lang="en-US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306CAF1-6C20-4423-8FAB-CA6E189BE59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682838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6458228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7042742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298723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2295994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481079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41140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79883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910193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0424973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904064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it-IT"/>
              <a:t>Fare clic sull'icona per inserire un'immagin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stili del testo dello schema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815130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5DDAB-305D-46A6-89E0-0710D2192744}" type="datetimeFigureOut">
              <a:rPr lang="en-US" smtClean="0"/>
              <a:t>4/9/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518617-3026-45A7-9D1D-94467C5A22E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42170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4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6.xml.rels><?xml version="1.0" encoding="UTF-8" standalone="yes"?>
<Relationships xmlns="http://schemas.openxmlformats.org/package/2006/relationships"><Relationship Id="rId8" Type="http://schemas.openxmlformats.org/officeDocument/2006/relationships/hyperlink" Target="https://pubmed.ncbi.nlm.nih.gov/24254547/" TargetMode="External"/><Relationship Id="rId3" Type="http://schemas.openxmlformats.org/officeDocument/2006/relationships/hyperlink" Target="https://pubmed.ncbi.nlm.nih.gov/32816326/" TargetMode="External"/><Relationship Id="rId7" Type="http://schemas.openxmlformats.org/officeDocument/2006/relationships/hyperlink" Target="https://pubmed.ncbi.nlm.nih.gov/25115509/" TargetMode="External"/><Relationship Id="rId2" Type="http://schemas.openxmlformats.org/officeDocument/2006/relationships/hyperlink" Target="https://pubmed-ncbi-nlm-nih-gov.bibliopass.unito.it/32309784/" TargetMode="External"/><Relationship Id="rId1" Type="http://schemas.openxmlformats.org/officeDocument/2006/relationships/slideLayout" Target="../slideLayouts/slideLayout7.xml"/><Relationship Id="rId6" Type="http://schemas.openxmlformats.org/officeDocument/2006/relationships/hyperlink" Target="https://pubmed.ncbi.nlm.nih.gov/29205868/" TargetMode="External"/><Relationship Id="rId5" Type="http://schemas.openxmlformats.org/officeDocument/2006/relationships/hyperlink" Target="https://pubmed.ncbi.nlm.nih.gov/31293969/" TargetMode="External"/><Relationship Id="rId4" Type="http://schemas.openxmlformats.org/officeDocument/2006/relationships/hyperlink" Target="https://pubmed.ncbi.nlm.nih.gov/31325190/" TargetMode="Externa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2" name="Gruppo 1"/>
          <p:cNvGrpSpPr/>
          <p:nvPr/>
        </p:nvGrpSpPr>
        <p:grpSpPr>
          <a:xfrm>
            <a:off x="64188" y="337135"/>
            <a:ext cx="9080149" cy="5753731"/>
            <a:chOff x="60960" y="337135"/>
            <a:chExt cx="9080149" cy="5753731"/>
          </a:xfrm>
        </p:grpSpPr>
        <p:grpSp>
          <p:nvGrpSpPr>
            <p:cNvPr id="13" name="Gruppo 12"/>
            <p:cNvGrpSpPr/>
            <p:nvPr/>
          </p:nvGrpSpPr>
          <p:grpSpPr>
            <a:xfrm>
              <a:off x="60960" y="2011034"/>
              <a:ext cx="8879554" cy="3052938"/>
              <a:chOff x="0" y="2733755"/>
              <a:chExt cx="8879554" cy="2818112"/>
            </a:xfrm>
          </p:grpSpPr>
          <p:sp>
            <p:nvSpPr>
              <p:cNvPr id="10" name="Figura a mano libera 9"/>
              <p:cNvSpPr/>
              <p:nvPr/>
            </p:nvSpPr>
            <p:spPr>
              <a:xfrm>
                <a:off x="0" y="2770030"/>
                <a:ext cx="8345510" cy="2781837"/>
              </a:xfrm>
              <a:custGeom>
                <a:avLst/>
                <a:gdLst>
                  <a:gd name="connsiteX0" fmla="*/ 0 w 8345510"/>
                  <a:gd name="connsiteY0" fmla="*/ 0 h 2537138"/>
                  <a:gd name="connsiteX1" fmla="*/ 4159876 w 8345510"/>
                  <a:gd name="connsiteY1" fmla="*/ 502276 h 2537138"/>
                  <a:gd name="connsiteX2" fmla="*/ 2704563 w 8345510"/>
                  <a:gd name="connsiteY2" fmla="*/ 1416676 h 2537138"/>
                  <a:gd name="connsiteX3" fmla="*/ 8345510 w 8345510"/>
                  <a:gd name="connsiteY3" fmla="*/ 2537138 h 2537138"/>
                  <a:gd name="connsiteX4" fmla="*/ 8345510 w 8345510"/>
                  <a:gd name="connsiteY4" fmla="*/ 2537138 h 2537138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</a:cxnLst>
                <a:rect l="l" t="t" r="r" b="b"/>
                <a:pathLst>
                  <a:path w="8345510" h="2537138">
                    <a:moveTo>
                      <a:pt x="0" y="0"/>
                    </a:moveTo>
                    <a:cubicBezTo>
                      <a:pt x="1854558" y="133081"/>
                      <a:pt x="3709116" y="266163"/>
                      <a:pt x="4159876" y="502276"/>
                    </a:cubicBezTo>
                    <a:cubicBezTo>
                      <a:pt x="4610636" y="738389"/>
                      <a:pt x="2006957" y="1077532"/>
                      <a:pt x="2704563" y="1416676"/>
                    </a:cubicBezTo>
                    <a:cubicBezTo>
                      <a:pt x="3402169" y="1755820"/>
                      <a:pt x="8345510" y="2537138"/>
                      <a:pt x="8345510" y="2537138"/>
                    </a:cubicBezTo>
                    <a:lnTo>
                      <a:pt x="8345510" y="2537138"/>
                    </a:lnTo>
                  </a:path>
                </a:pathLst>
              </a:custGeom>
              <a:noFill/>
              <a:ln w="762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  <p:sp>
            <p:nvSpPr>
              <p:cNvPr id="12" name="Figura a mano libera 11"/>
              <p:cNvSpPr/>
              <p:nvPr/>
            </p:nvSpPr>
            <p:spPr>
              <a:xfrm>
                <a:off x="418134" y="2733755"/>
                <a:ext cx="8461420" cy="2485623"/>
              </a:xfrm>
              <a:custGeom>
                <a:avLst/>
                <a:gdLst>
                  <a:gd name="connsiteX0" fmla="*/ 0 w 8461420"/>
                  <a:gd name="connsiteY0" fmla="*/ 0 h 2485623"/>
                  <a:gd name="connsiteX1" fmla="*/ 4597758 w 8461420"/>
                  <a:gd name="connsiteY1" fmla="*/ 540913 h 2485623"/>
                  <a:gd name="connsiteX2" fmla="*/ 2807595 w 8461420"/>
                  <a:gd name="connsiteY2" fmla="*/ 1455313 h 2485623"/>
                  <a:gd name="connsiteX3" fmla="*/ 8461420 w 8461420"/>
                  <a:gd name="connsiteY3" fmla="*/ 2485623 h 2485623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</a:cxnLst>
                <a:rect l="l" t="t" r="r" b="b"/>
                <a:pathLst>
                  <a:path w="8461420" h="2485623">
                    <a:moveTo>
                      <a:pt x="0" y="0"/>
                    </a:moveTo>
                    <a:cubicBezTo>
                      <a:pt x="2064913" y="149180"/>
                      <a:pt x="4129826" y="298361"/>
                      <a:pt x="4597758" y="540913"/>
                    </a:cubicBezTo>
                    <a:cubicBezTo>
                      <a:pt x="5065690" y="783465"/>
                      <a:pt x="2163651" y="1131195"/>
                      <a:pt x="2807595" y="1455313"/>
                    </a:cubicBezTo>
                    <a:cubicBezTo>
                      <a:pt x="3451539" y="1779431"/>
                      <a:pt x="5956479" y="2132527"/>
                      <a:pt x="8461420" y="2485623"/>
                    </a:cubicBezTo>
                  </a:path>
                </a:pathLst>
              </a:custGeom>
              <a:noFill/>
              <a:ln w="76200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/>
              </a:p>
            </p:txBody>
          </p:sp>
        </p:grpSp>
        <p:sp>
          <p:nvSpPr>
            <p:cNvPr id="18" name="Freccia a destra 17"/>
            <p:cNvSpPr/>
            <p:nvPr/>
          </p:nvSpPr>
          <p:spPr>
            <a:xfrm rot="484901">
              <a:off x="7897314" y="4419944"/>
              <a:ext cx="1243795" cy="873279"/>
            </a:xfrm>
            <a:prstGeom prst="rightArrow">
              <a:avLst/>
            </a:prstGeom>
            <a:solidFill>
              <a:schemeClr val="bg1"/>
            </a:solidFill>
            <a:ln w="76200"/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  <p:pic>
          <p:nvPicPr>
            <p:cNvPr id="38" name="Immagine 37"/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7717255" y="2961622"/>
              <a:ext cx="723900" cy="990600"/>
            </a:xfrm>
            <a:prstGeom prst="rect">
              <a:avLst/>
            </a:prstGeom>
          </p:spPr>
        </p:pic>
        <p:sp>
          <p:nvSpPr>
            <p:cNvPr id="42" name="Rettangolo 41"/>
            <p:cNvSpPr/>
            <p:nvPr/>
          </p:nvSpPr>
          <p:spPr>
            <a:xfrm>
              <a:off x="482374" y="337135"/>
              <a:ext cx="2661180" cy="800219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/>
                <a:t>Establishment of European Study Group on </a:t>
              </a:r>
              <a:r>
                <a:rPr lang="en-US" sz="1400" b="1" dirty="0" err="1"/>
                <a:t>MRD</a:t>
              </a:r>
              <a:r>
                <a:rPr lang="en-US" sz="1400" b="1" dirty="0"/>
                <a:t> detection in ALL (</a:t>
              </a:r>
              <a:r>
                <a:rPr lang="en-US" b="1" dirty="0" err="1"/>
                <a:t>EuroMRD</a:t>
              </a:r>
              <a:r>
                <a:rPr lang="en-US" sz="1400" b="1" dirty="0"/>
                <a:t>)</a:t>
              </a:r>
            </a:p>
          </p:txBody>
        </p:sp>
        <p:pic>
          <p:nvPicPr>
            <p:cNvPr id="44" name="Immagine 43"/>
            <p:cNvPicPr>
              <a:picLocks noChangeAspect="1"/>
            </p:cNvPicPr>
            <p:nvPr/>
          </p:nvPicPr>
          <p:blipFill>
            <a:blip r:embed="rId3"/>
            <a:stretch>
              <a:fillRect/>
            </a:stretch>
          </p:blipFill>
          <p:spPr>
            <a:xfrm>
              <a:off x="209474" y="859039"/>
              <a:ext cx="714375" cy="942975"/>
            </a:xfrm>
            <a:prstGeom prst="rect">
              <a:avLst/>
            </a:prstGeom>
          </p:spPr>
        </p:pic>
        <p:pic>
          <p:nvPicPr>
            <p:cNvPr id="45" name="Immagine 44"/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4677916" y="1522148"/>
              <a:ext cx="819150" cy="895350"/>
            </a:xfrm>
            <a:prstGeom prst="rect">
              <a:avLst/>
            </a:prstGeom>
          </p:spPr>
        </p:pic>
        <p:pic>
          <p:nvPicPr>
            <p:cNvPr id="46" name="Immagine 45"/>
            <p:cNvPicPr>
              <a:picLocks noChangeAspect="1"/>
            </p:cNvPicPr>
            <p:nvPr/>
          </p:nvPicPr>
          <p:blipFill>
            <a:blip r:embed="rId5"/>
            <a:stretch>
              <a:fillRect/>
            </a:stretch>
          </p:blipFill>
          <p:spPr>
            <a:xfrm>
              <a:off x="1649722" y="2795463"/>
              <a:ext cx="790575" cy="866775"/>
            </a:xfrm>
            <a:prstGeom prst="rect">
              <a:avLst/>
            </a:prstGeom>
          </p:spPr>
        </p:pic>
        <p:sp>
          <p:nvSpPr>
            <p:cNvPr id="47" name="Rettangolo 46"/>
            <p:cNvSpPr/>
            <p:nvPr/>
          </p:nvSpPr>
          <p:spPr>
            <a:xfrm>
              <a:off x="6267206" y="5136759"/>
              <a:ext cx="2322001" cy="954107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>
                  <a:latin typeface="arial" panose="020B0604020202020204" pitchFamily="34" charset="0"/>
                </a:rPr>
                <a:t>The FIL MRD network laboratories joined the </a:t>
              </a:r>
              <a:r>
                <a:rPr lang="en-US" sz="1400" b="1" dirty="0" err="1"/>
                <a:t>EuroMRD</a:t>
              </a:r>
              <a:r>
                <a:rPr lang="en-US" sz="1400" b="1" dirty="0">
                  <a:latin typeface="arial" panose="020B0604020202020204" pitchFamily="34" charset="0"/>
                </a:rPr>
                <a:t> Lymphomas group  </a:t>
              </a:r>
              <a:endParaRPr lang="en-US" sz="1400" b="1" dirty="0"/>
            </a:p>
          </p:txBody>
        </p:sp>
        <p:sp>
          <p:nvSpPr>
            <p:cNvPr id="48" name="CasellaDiTesto 47"/>
            <p:cNvSpPr txBox="1"/>
            <p:nvPr/>
          </p:nvSpPr>
          <p:spPr>
            <a:xfrm>
              <a:off x="823755" y="1555996"/>
              <a:ext cx="8066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2001</a:t>
              </a:r>
            </a:p>
          </p:txBody>
        </p:sp>
        <p:sp>
          <p:nvSpPr>
            <p:cNvPr id="49" name="CasellaDiTesto 48"/>
            <p:cNvSpPr txBox="1"/>
            <p:nvPr/>
          </p:nvSpPr>
          <p:spPr>
            <a:xfrm>
              <a:off x="7622994" y="3857280"/>
              <a:ext cx="8066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2018</a:t>
              </a:r>
            </a:p>
          </p:txBody>
        </p:sp>
        <p:sp>
          <p:nvSpPr>
            <p:cNvPr id="51" name="CasellaDiTesto 50"/>
            <p:cNvSpPr txBox="1"/>
            <p:nvPr/>
          </p:nvSpPr>
          <p:spPr>
            <a:xfrm>
              <a:off x="856452" y="3429000"/>
              <a:ext cx="8066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2009</a:t>
              </a:r>
            </a:p>
          </p:txBody>
        </p:sp>
        <p:sp>
          <p:nvSpPr>
            <p:cNvPr id="52" name="Rettangolo 51"/>
            <p:cNvSpPr/>
            <p:nvPr/>
          </p:nvSpPr>
          <p:spPr>
            <a:xfrm>
              <a:off x="5384453" y="1293058"/>
              <a:ext cx="2661180" cy="73866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/>
                <a:t>Establishment of European Study Group on </a:t>
              </a:r>
              <a:r>
                <a:rPr lang="en-US" sz="1400" b="1" dirty="0" err="1"/>
                <a:t>MRD</a:t>
              </a:r>
              <a:r>
                <a:rPr lang="en-US" sz="1400" b="1" dirty="0"/>
                <a:t> detection in Lymphomas (</a:t>
              </a:r>
              <a:r>
                <a:rPr lang="en-US" sz="1400" b="1" dirty="0" err="1"/>
                <a:t>EuroMRD</a:t>
              </a:r>
              <a:r>
                <a:rPr lang="en-US" sz="1400" b="1" dirty="0"/>
                <a:t>)</a:t>
              </a:r>
            </a:p>
          </p:txBody>
        </p:sp>
        <p:sp>
          <p:nvSpPr>
            <p:cNvPr id="53" name="Rettangolo 52"/>
            <p:cNvSpPr/>
            <p:nvPr/>
          </p:nvSpPr>
          <p:spPr>
            <a:xfrm>
              <a:off x="617266" y="3938167"/>
              <a:ext cx="2125617" cy="58477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400" b="1" dirty="0"/>
                <a:t>Establishment of Italian </a:t>
              </a:r>
              <a:r>
                <a:rPr lang="en-US" b="1" dirty="0"/>
                <a:t>FIL</a:t>
              </a:r>
              <a:r>
                <a:rPr lang="en-US" sz="1400" b="1" dirty="0"/>
                <a:t> </a:t>
              </a:r>
              <a:r>
                <a:rPr lang="en-US" b="1" dirty="0"/>
                <a:t>MRD Network</a:t>
              </a:r>
              <a:endParaRPr lang="en-US" sz="1400" b="1" dirty="0"/>
            </a:p>
          </p:txBody>
        </p:sp>
        <p:sp>
          <p:nvSpPr>
            <p:cNvPr id="55" name="CasellaDiTesto 54"/>
            <p:cNvSpPr txBox="1"/>
            <p:nvPr/>
          </p:nvSpPr>
          <p:spPr>
            <a:xfrm>
              <a:off x="5369781" y="2331532"/>
              <a:ext cx="806631" cy="46166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sz="2400" b="1" dirty="0"/>
                <a:t>2008</a:t>
              </a:r>
            </a:p>
          </p:txBody>
        </p:sp>
      </p:grpSp>
      <p:sp>
        <p:nvSpPr>
          <p:cNvPr id="22" name="CasellaDiTesto 21"/>
          <p:cNvSpPr txBox="1"/>
          <p:nvPr/>
        </p:nvSpPr>
        <p:spPr>
          <a:xfrm>
            <a:off x="193863" y="6345888"/>
            <a:ext cx="7921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DC Figure 1S. Timeline of the European and Italian MRD standardization program. </a:t>
            </a:r>
          </a:p>
        </p:txBody>
      </p:sp>
      <p:pic>
        <p:nvPicPr>
          <p:cNvPr id="3" name="Immagine 2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2628492" y="4159390"/>
            <a:ext cx="1065049" cy="1320123"/>
          </a:xfrm>
          <a:prstGeom prst="rect">
            <a:avLst/>
          </a:prstGeom>
        </p:spPr>
      </p:pic>
      <p:sp>
        <p:nvSpPr>
          <p:cNvPr id="4" name="Oval 3">
            <a:extLst>
              <a:ext uri="{FF2B5EF4-FFF2-40B4-BE49-F238E27FC236}">
                <a16:creationId xmlns:a16="http://schemas.microsoft.com/office/drawing/2014/main" id="{45A7FEE1-D2B7-BD40-B005-970C7D5EF37A}"/>
              </a:ext>
            </a:extLst>
          </p:cNvPr>
          <p:cNvSpPr/>
          <p:nvPr/>
        </p:nvSpPr>
        <p:spPr>
          <a:xfrm>
            <a:off x="7720483" y="4605215"/>
            <a:ext cx="384426" cy="313150"/>
          </a:xfrm>
          <a:prstGeom prst="ellipse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x-none"/>
          </a:p>
        </p:txBody>
      </p:sp>
    </p:spTree>
    <p:extLst>
      <p:ext uri="{BB962C8B-B14F-4D97-AF65-F5344CB8AC3E}">
        <p14:creationId xmlns:p14="http://schemas.microsoft.com/office/powerpoint/2010/main" val="93982727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el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407864661"/>
              </p:ext>
            </p:extLst>
          </p:nvPr>
        </p:nvGraphicFramePr>
        <p:xfrm>
          <a:off x="137281" y="191853"/>
          <a:ext cx="8815800" cy="6159182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31784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5123565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39159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721292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578842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3366"/>
                          </a:solidFill>
                          <a:effectLst/>
                          <a:latin typeface="Calibri" panose="020F0502020204030204" pitchFamily="34" charset="0"/>
                        </a:rPr>
                        <a:t>Protocol ID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3366"/>
                          </a:solidFill>
                          <a:effectLst/>
                          <a:latin typeface="Calibri" panose="020F0502020204030204" pitchFamily="34" charset="0"/>
                        </a:rPr>
                        <a:t> Protocol Description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3366"/>
                          </a:solidFill>
                          <a:effectLst/>
                          <a:latin typeface="Calibri" panose="020F0502020204030204" pitchFamily="34" charset="0"/>
                        </a:rPr>
                        <a:t>EudraCT number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3366"/>
                          </a:solidFill>
                          <a:effectLst/>
                          <a:latin typeface="Calibri" panose="020F0502020204030204" pitchFamily="34" charset="0"/>
                        </a:rPr>
                        <a:t>Phase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1010438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LAZ-12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multicenter, randomized study comparing consolidation with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Yttrium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Labeled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britumomab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iuxeta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Zevalin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®) Radio-immunotherapy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s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utologous Stem Cell Transplantation in patients with relapsed/refractory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icular Lymphoma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, aged 18-65 years  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2-000251-14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90960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12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multicenter, randomized study to evaluate the efficacy of a response-adapted strategy to define maintenance after standard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chemoimmunotherapy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 patients with advanced-stage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icular Lymphoma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2-003170-60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758673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IRO'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olecularly Oriented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mmuno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-radio-therapy: multicenter II study for the treatment on molecular basis of Stage I / II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icular Lymphoma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with local radiotherapy with / without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Ofatumumab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2-001676-11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1262204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ENOIR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A randomized multicenter trial assessing efficacy and toxicity of a combination of Rituximab and Lenalidomide vs Rituximab alone as maintenance after chemoimmunotherapy with Rituximab-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ndamustine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for relapsed/refractory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icular Lymphoma</a:t>
                      </a:r>
                      <a:r>
                        <a:rPr lang="en-US" sz="16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atients not eligible for autologous transplantation.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2-003393-18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714499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-RBAC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Rituximab, </a:t>
                      </a: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bendamustine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and cytarabine followed by </a:t>
                      </a:r>
                      <a:b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</a:br>
                      <a:r>
                        <a:rPr lang="en-US" sz="1400" b="0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venetoclax</a:t>
                      </a:r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in high-risk elderly patients with </a:t>
                      </a:r>
                      <a:r>
                        <a:rPr lang="en-US" sz="16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Mantle  cell Lymphoma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017-004628-31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437591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FOLL19</a:t>
                      </a:r>
                      <a:endParaRPr lang="en-US" sz="16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just" fontAlgn="ctr"/>
                      <a:r>
                        <a:rPr lang="en-US" sz="1400" b="0" dirty="0"/>
                        <a:t>Shortened vs standard chemotherapy combined with immunotherapy for the initial treatment of patients with high tumor burden </a:t>
                      </a:r>
                      <a:r>
                        <a:rPr lang="en-US" sz="1600" b="1" dirty="0"/>
                        <a:t>Follicular Lymphoma</a:t>
                      </a:r>
                      <a:r>
                        <a:rPr lang="en-US" sz="1400" b="0" dirty="0"/>
                        <a:t>. A randomized, open label, phase III study by Fondazione </a:t>
                      </a:r>
                      <a:r>
                        <a:rPr lang="en-US" sz="1400" b="0" dirty="0" err="1"/>
                        <a:t>Italiana</a:t>
                      </a:r>
                      <a:r>
                        <a:rPr lang="en-US" sz="1400" b="0" dirty="0"/>
                        <a:t> </a:t>
                      </a:r>
                      <a:r>
                        <a:rPr lang="en-US" sz="1400" b="0" dirty="0" err="1"/>
                        <a:t>Linfomi</a:t>
                      </a:r>
                      <a:r>
                        <a:rPr lang="en-US" sz="1400" b="0" dirty="0"/>
                        <a:t>. 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400" b="0" i="0" u="none" strike="noStrike" kern="1200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  <a:ea typeface="+mn-ea"/>
                          <a:cs typeface="+mn-cs"/>
                        </a:rPr>
                        <a:t>2020-003277-22</a:t>
                      </a:r>
                      <a:r>
                        <a:rPr lang="x-none" sz="18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 </a:t>
                      </a:r>
                      <a:endParaRPr lang="en-US" sz="14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400" b="0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III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4" name="CasellaDiTesto 3"/>
          <p:cNvSpPr txBox="1"/>
          <p:nvPr/>
        </p:nvSpPr>
        <p:spPr>
          <a:xfrm>
            <a:off x="167426" y="6488668"/>
            <a:ext cx="836421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DC Table 1S. Description of trials for MRD analysis performed by the FIL MRD-Network </a:t>
            </a:r>
          </a:p>
        </p:txBody>
      </p:sp>
    </p:spTree>
    <p:extLst>
      <p:ext uri="{BB962C8B-B14F-4D97-AF65-F5344CB8AC3E}">
        <p14:creationId xmlns:p14="http://schemas.microsoft.com/office/powerpoint/2010/main" val="3271469201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968431911"/>
              </p:ext>
            </p:extLst>
          </p:nvPr>
        </p:nvGraphicFramePr>
        <p:xfrm>
          <a:off x="643940" y="296207"/>
          <a:ext cx="7881874" cy="5859893"/>
        </p:xfrm>
        <a:graphic>
          <a:graphicData uri="http://schemas.openxmlformats.org/drawingml/2006/table">
            <a:tbl>
              <a:tblPr firstRow="1" bandRow="1">
                <a:tableStyleId>{C083E6E3-FA7D-4D7B-A595-EF9225AFEA82}</a:tableStyleId>
              </a:tblPr>
              <a:tblGrid>
                <a:gridCol w="1057682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34772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695183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  <a:gridCol w="1651710">
                  <a:extLst>
                    <a:ext uri="{9D8B030D-6E8A-4147-A177-3AD203B41FA5}">
                      <a16:colId xmlns:a16="http://schemas.microsoft.com/office/drawing/2014/main" val="20003"/>
                    </a:ext>
                  </a:extLst>
                </a:gridCol>
              </a:tblGrid>
              <a:tr h="641706"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800" b="1" u="none" strike="noStrike" dirty="0">
                          <a:effectLst/>
                        </a:rPr>
                        <a:t>TASK #</a:t>
                      </a:r>
                      <a:endParaRPr lang="it-IT" sz="18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it-IT" sz="1800" b="1" u="none" strike="noStrike" dirty="0" err="1">
                          <a:effectLst/>
                        </a:rPr>
                        <a:t>DESCRIPTION</a:t>
                      </a:r>
                      <a:endParaRPr lang="it-IT" sz="18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800" b="1" u="none" strike="noStrike" dirty="0" err="1">
                          <a:effectLst/>
                        </a:rPr>
                        <a:t>MRD</a:t>
                      </a:r>
                      <a:r>
                        <a:rPr lang="it-IT" sz="1800" b="1" u="none" strike="noStrike" dirty="0">
                          <a:effectLst/>
                        </a:rPr>
                        <a:t> MARKER</a:t>
                      </a:r>
                      <a:endParaRPr lang="it-IT" sz="18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algn="ctr" rtl="0" fontAlgn="ctr"/>
                      <a:r>
                        <a:rPr lang="it-IT" sz="1800" b="1" u="none" strike="noStrike" dirty="0">
                          <a:effectLst/>
                        </a:rPr>
                        <a:t>METHOD</a:t>
                      </a:r>
                      <a:endParaRPr lang="it-IT" sz="1800" b="1" i="0" u="none" strike="noStrike" dirty="0">
                        <a:solidFill>
                          <a:srgbClr val="FFFFFF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1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qPC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nterpretation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Euro-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r>
                        <a:rPr lang="it-IT" sz="1400" b="1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u="none" strike="noStrike" baseline="0" dirty="0" err="1">
                          <a:effectLst/>
                          <a:latin typeface="+mn-lt"/>
                        </a:rPr>
                        <a:t>guidelines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2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qualitative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PC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for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BCL2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/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(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B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)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Nested-PCR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3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quantitative </a:t>
                      </a:r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PCR</a:t>
                      </a:r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 for </a:t>
                      </a:r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BCL2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/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(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B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)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>
                          <a:effectLst/>
                          <a:latin typeface="+mn-lt"/>
                        </a:rPr>
                        <a:t>qPCR</a:t>
                      </a:r>
                      <a:endParaRPr lang="it-IT" sz="1400" b="1" i="0" u="none" strike="noStrike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726245">
                <a:tc>
                  <a:txBody>
                    <a:bodyPr/>
                    <a:lstStyle/>
                    <a:p>
                      <a:pPr marL="457200" marR="0" lvl="1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1400" b="1" u="none" strike="noStrike" dirty="0">
                        <a:effectLst/>
                        <a:latin typeface="+mn-lt"/>
                      </a:endParaRPr>
                    </a:p>
                    <a:p>
                      <a:pPr marL="457200" marR="0" lvl="1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4A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it-IT" sz="14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Sequence</a:t>
                      </a:r>
                      <a:r>
                        <a:rPr lang="it-IT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analysis</a:t>
                      </a:r>
                      <a:r>
                        <a:rPr lang="it-IT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, </a:t>
                      </a:r>
                    </a:p>
                    <a:p>
                      <a:pPr lvl="1" algn="ctr" fontAlgn="ctr"/>
                      <a:r>
                        <a:rPr lang="it-IT" sz="1400" b="1" i="0" u="none" strike="noStrike" baseline="0" dirty="0" err="1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primers</a:t>
                      </a:r>
                      <a:r>
                        <a:rPr lang="it-IT" sz="1400" b="1" i="0" u="none" strike="noStrike" baseline="0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/probe design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marL="457200" marR="0" lvl="1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it-IT" sz="1400" b="1" u="none" strike="noStrike" dirty="0">
                        <a:effectLst/>
                        <a:latin typeface="+mn-lt"/>
                      </a:endParaRPr>
                    </a:p>
                    <a:p>
                      <a:pPr marL="457200" marR="0" lvl="1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marL="457200" marR="0" lvl="1" indent="0" algn="ctr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Euro-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r>
                        <a:rPr lang="it-IT" sz="1400" b="1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u="none" strike="noStrike" baseline="0" dirty="0" err="1">
                          <a:effectLst/>
                          <a:latin typeface="+mn-lt"/>
                        </a:rPr>
                        <a:t>guidelines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  <a:p>
                      <a:pPr lvl="1" algn="ctr" rtl="0" fontAlgn="ctr"/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4B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 qualitative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PC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Nested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-PCR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4C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quantitative </a:t>
                      </a:r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PCR</a:t>
                      </a:r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 for </a:t>
                      </a:r>
                      <a:r>
                        <a:rPr lang="en-US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r>
                        <a:rPr lang="en-US" sz="1400" b="1" u="none" strike="noStrike" dirty="0">
                          <a:effectLst/>
                          <a:latin typeface="+mn-lt"/>
                        </a:rPr>
                        <a:t> </a:t>
                      </a:r>
                      <a:endParaRPr lang="en-US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BCL1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/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qPCR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5</a:t>
                      </a:r>
                      <a:endParaRPr lang="it-IT" sz="1400" b="1" i="0" u="none" strike="noStrike" dirty="0">
                        <a:solidFill>
                          <a:srgbClr val="FFFFFF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Absolute quantitative</a:t>
                      </a:r>
                      <a:r>
                        <a:rPr lang="it-IT" sz="1400" b="1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PC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for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BCL2/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ddPCR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7"/>
                  </a:ext>
                </a:extLst>
              </a:tr>
              <a:tr h="641706">
                <a:tc>
                  <a:txBody>
                    <a:bodyPr/>
                    <a:lstStyle/>
                    <a:p>
                      <a:pPr lvl="1" algn="l" rtl="0" fontAlgn="ctr"/>
                      <a:r>
                        <a:rPr lang="it-IT" sz="1400" b="1" i="0" u="none" strike="noStrike" dirty="0">
                          <a:solidFill>
                            <a:schemeClr val="tx1"/>
                          </a:solidFill>
                          <a:effectLst/>
                          <a:latin typeface="+mn-lt"/>
                        </a:rPr>
                        <a:t>6</a:t>
                      </a: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fontAlgn="ctr"/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Absolute</a:t>
                      </a:r>
                      <a:r>
                        <a:rPr lang="it-IT" sz="1400" b="1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quantitative</a:t>
                      </a:r>
                      <a:r>
                        <a:rPr lang="it-IT" sz="1400" b="1" u="none" strike="noStrike" baseline="0" dirty="0">
                          <a:effectLst/>
                          <a:latin typeface="+mn-lt"/>
                        </a:rPr>
                        <a:t>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PCR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for 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MRD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 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r>
                        <a:rPr lang="it-IT" sz="1400" b="1" u="none" strike="noStrike" dirty="0">
                          <a:effectLst/>
                          <a:latin typeface="+mn-lt"/>
                        </a:rPr>
                        <a:t>, BCL1/</a:t>
                      </a:r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IgH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tc>
                  <a:txBody>
                    <a:bodyPr/>
                    <a:lstStyle/>
                    <a:p>
                      <a:pPr lvl="1" algn="ctr" rtl="0" fontAlgn="ctr"/>
                      <a:r>
                        <a:rPr lang="it-IT" sz="1400" b="1" u="none" strike="noStrike" dirty="0" err="1">
                          <a:effectLst/>
                          <a:latin typeface="+mn-lt"/>
                        </a:rPr>
                        <a:t>ddPCR</a:t>
                      </a:r>
                      <a:endParaRPr lang="it-IT" sz="14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</a:endParaRPr>
                    </a:p>
                  </a:txBody>
                  <a:tcPr marL="5977" marR="5977" marT="4484" marB="0" anchor="ctr"/>
                </a:tc>
                <a:extLst>
                  <a:ext uri="{0D108BD9-81ED-4DB2-BD59-A6C34878D82A}">
                    <a16:rowId xmlns:a16="http://schemas.microsoft.com/office/drawing/2014/main" val="10008"/>
                  </a:ext>
                </a:extLst>
              </a:tr>
            </a:tbl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347730" y="6272011"/>
            <a:ext cx="754591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DC Table 2S. Description of tasks performed by the four labs of </a:t>
            </a:r>
            <a:r>
              <a:rPr lang="en-US" dirty="0" err="1"/>
              <a:t>MRD</a:t>
            </a:r>
            <a:r>
              <a:rPr lang="en-US" dirty="0"/>
              <a:t>-Network </a:t>
            </a:r>
          </a:p>
        </p:txBody>
      </p:sp>
    </p:spTree>
    <p:extLst>
      <p:ext uri="{BB962C8B-B14F-4D97-AF65-F5344CB8AC3E}">
        <p14:creationId xmlns:p14="http://schemas.microsoft.com/office/powerpoint/2010/main" val="380203216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Tabella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598703634"/>
              </p:ext>
            </p:extLst>
          </p:nvPr>
        </p:nvGraphicFramePr>
        <p:xfrm>
          <a:off x="141669" y="244700"/>
          <a:ext cx="8899300" cy="5939075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28096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61834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801925"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TASKS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PERFORMANCE EVALUATION </a:t>
                      </a: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180000"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1.5 points is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awarded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correct definition of sensitivity (S);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1.5 points is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awarded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correct definition quantitative range (</a:t>
                      </a:r>
                      <a:r>
                        <a:rPr lang="en-US" sz="1200" b="0" i="0" u="none" strike="noStrike" dirty="0" err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QR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);    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1/7 points is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awarded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each correct classification of FU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(maximum score = 10 points)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endParaRPr lang="en-US" sz="12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180000"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, </a:t>
                      </a:r>
                      <a:r>
                        <a:rPr lang="en-US" sz="1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B</a:t>
                      </a:r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 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1 point is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awarded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each </a:t>
                      </a:r>
                      <a:r>
                        <a:rPr lang="en-US" sz="1200" b="0" i="0" u="none" strike="noStrike" dirty="0" err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PCR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concordant with the reference (reference= scientific organizer </a:t>
                      </a:r>
                      <a:r>
                        <a:rPr lang="en-US" sz="1200" b="0" i="0" u="none" strike="noStrike" dirty="0" err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PCR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result)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endParaRPr lang="en-US" sz="12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180000"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 and </a:t>
                      </a:r>
                      <a:r>
                        <a:rPr lang="en-US" sz="1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C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1.5 points is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awarded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correct definition of sensitivity (S);  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1.5 points is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awarded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correct definition of quantitative range (</a:t>
                      </a:r>
                      <a:r>
                        <a:rPr lang="en-US" sz="1200" b="0" i="0" u="none" strike="noStrike" dirty="0" err="1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QR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);   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1/7 points is awarded</a:t>
                      </a:r>
                      <a:r>
                        <a:rPr lang="en-US" sz="1200" b="0" i="0" u="none" strike="noStrike" baseline="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 </a:t>
                      </a: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for each correct classification of FU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(maximum score = 10 points)  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kern="1200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  <a:ea typeface="+mn-ea"/>
                          <a:cs typeface="+mn-cs"/>
                        </a:rPr>
                        <a:t>correct FU sample: whether ≤ 1 log from the reference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endParaRPr lang="en-US" sz="12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180000" algn="ctr" fontAlgn="ctr"/>
                      <a:r>
                        <a:rPr lang="en-US" sz="1800" b="1" i="0" u="none" strike="noStrike" dirty="0" err="1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A</a:t>
                      </a:r>
                      <a:endParaRPr lang="en-US" sz="18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1 point is awarded for each evaluation concordant with the scientific promoter 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or consensus results are independently confirmed by at least 3 laboratories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endParaRPr lang="en-US" sz="12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4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180000"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no uncertainty rules have been established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endParaRPr lang="en-US" sz="12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370840">
                <a:tc>
                  <a:txBody>
                    <a:bodyPr/>
                    <a:lstStyle/>
                    <a:p>
                      <a:pPr marL="180000" algn="ctr" fontAlgn="ctr"/>
                      <a:r>
                        <a:rPr lang="en-US" sz="18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9525" marR="9525" marT="9525" marB="0" anchor="ctr"/>
                </a:tc>
                <a:tc>
                  <a:txBody>
                    <a:bodyPr/>
                    <a:lstStyle/>
                    <a:p>
                      <a:pPr marL="180000" algn="just" fontAlgn="ctr">
                        <a:lnSpc>
                          <a:spcPts val="2000"/>
                        </a:lnSpc>
                      </a:pPr>
                      <a:r>
                        <a:rPr lang="en-US" sz="1200" b="0" i="0" u="none" strike="noStrike" dirty="0">
                          <a:solidFill>
                            <a:srgbClr val="212121"/>
                          </a:solidFill>
                          <a:effectLst/>
                          <a:latin typeface="Arial" panose="020B0604020202020204" pitchFamily="34" charset="0"/>
                        </a:rPr>
                        <a:t>no uncertainty rules have been established</a:t>
                      </a:r>
                    </a:p>
                    <a:p>
                      <a:pPr marL="180000" algn="just" fontAlgn="ctr">
                        <a:lnSpc>
                          <a:spcPts val="2000"/>
                        </a:lnSpc>
                      </a:pPr>
                      <a:endParaRPr lang="en-US" sz="1200" b="0" i="0" u="none" strike="noStrike" dirty="0">
                        <a:solidFill>
                          <a:srgbClr val="212121"/>
                        </a:solidFill>
                        <a:effectLst/>
                        <a:latin typeface="Arial" panose="020B0604020202020204" pitchFamily="34" charset="0"/>
                      </a:endParaRPr>
                    </a:p>
                  </a:txBody>
                  <a:tcPr marL="9525" marR="9525" marT="9525" marB="0" anchor="ctr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3" name="CasellaDiTesto 2"/>
          <p:cNvSpPr txBox="1"/>
          <p:nvPr/>
        </p:nvSpPr>
        <p:spPr>
          <a:xfrm>
            <a:off x="167426" y="6336405"/>
            <a:ext cx="669760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DC Table 3S. Description of tasks scored for concordances of analysis </a:t>
            </a:r>
          </a:p>
        </p:txBody>
      </p:sp>
    </p:spTree>
    <p:extLst>
      <p:ext uri="{BB962C8B-B14F-4D97-AF65-F5344CB8AC3E}">
        <p14:creationId xmlns:p14="http://schemas.microsoft.com/office/powerpoint/2010/main" val="113164096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CasellaDiTesto 2"/>
          <p:cNvSpPr txBox="1"/>
          <p:nvPr/>
        </p:nvSpPr>
        <p:spPr>
          <a:xfrm>
            <a:off x="358122" y="4202666"/>
            <a:ext cx="91598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SDC Table 4S. QCs performance for each task in terms of concordances (%) between laboratories</a:t>
            </a:r>
          </a:p>
        </p:txBody>
      </p:sp>
      <p:sp>
        <p:nvSpPr>
          <p:cNvPr id="4" name="Rettangolo 3"/>
          <p:cNvSpPr/>
          <p:nvPr/>
        </p:nvSpPr>
        <p:spPr>
          <a:xfrm>
            <a:off x="289902" y="1142998"/>
            <a:ext cx="8564196" cy="2286002"/>
          </a:xfrm>
          <a:prstGeom prst="rect">
            <a:avLst/>
          </a:prstGeom>
          <a:noFill/>
          <a:ln w="38100">
            <a:solidFill>
              <a:schemeClr val="tx1">
                <a:lumMod val="65000"/>
                <a:lumOff val="35000"/>
              </a:schemeClr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  <p:graphicFrame>
        <p:nvGraphicFramePr>
          <p:cNvPr id="6" name="Table 5">
            <a:extLst>
              <a:ext uri="{FF2B5EF4-FFF2-40B4-BE49-F238E27FC236}">
                <a16:creationId xmlns:a16="http://schemas.microsoft.com/office/drawing/2014/main" id="{CA594CD1-11B9-6742-91C4-9A956B42D261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90115273"/>
              </p:ext>
            </p:extLst>
          </p:nvPr>
        </p:nvGraphicFramePr>
        <p:xfrm>
          <a:off x="289901" y="1142998"/>
          <a:ext cx="8564197" cy="2286002"/>
        </p:xfrm>
        <a:graphic>
          <a:graphicData uri="http://schemas.openxmlformats.org/drawingml/2006/table">
            <a:tbl>
              <a:tblPr/>
              <a:tblGrid>
                <a:gridCol w="810757">
                  <a:extLst>
                    <a:ext uri="{9D8B030D-6E8A-4147-A177-3AD203B41FA5}">
                      <a16:colId xmlns:a16="http://schemas.microsoft.com/office/drawing/2014/main" val="49468920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2910493741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599786386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2249465046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2514109325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909029981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492635808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2044056001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1387876560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3927182720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513162492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951815744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3788590461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3295436044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3759451897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1152691018"/>
                    </a:ext>
                  </a:extLst>
                </a:gridCol>
                <a:gridCol w="484590">
                  <a:extLst>
                    <a:ext uri="{9D8B030D-6E8A-4147-A177-3AD203B41FA5}">
                      <a16:colId xmlns:a16="http://schemas.microsoft.com/office/drawing/2014/main" val="370112786"/>
                    </a:ext>
                  </a:extLst>
                </a:gridCol>
              </a:tblGrid>
              <a:tr h="553299">
                <a:tc>
                  <a:txBody>
                    <a:bodyPr/>
                    <a:lstStyle/>
                    <a:p>
                      <a:pPr algn="ctr" fontAlgn="ctr"/>
                      <a:r>
                        <a:rPr lang="en-GB" sz="16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QC #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2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3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4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5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6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1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2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3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4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5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x-none" sz="1600" b="0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6</a:t>
                      </a:r>
                    </a:p>
                  </a:txBody>
                  <a:tcPr marL="8585" marR="8585" marT="8585" marB="0" anchor="ctr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778123723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1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D9E1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5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9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4242455627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2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665289661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3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78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3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537955910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4b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1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>
                      <a:noFill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1346067028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4c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4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6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7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88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B4C6E7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1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2665899700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5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92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8EA9DB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824434173"/>
                  </a:ext>
                </a:extLst>
              </a:tr>
              <a:tr h="247529">
                <a:tc>
                  <a:txBody>
                    <a:bodyPr/>
                    <a:lstStyle/>
                    <a:p>
                      <a:pPr algn="ctr" fontAlgn="b"/>
                      <a:r>
                        <a:rPr lang="en-GB" sz="1100" b="1" i="0" u="none" strike="noStrike">
                          <a:solidFill>
                            <a:srgbClr val="000000"/>
                          </a:solidFill>
                          <a:effectLst/>
                          <a:latin typeface="Arial" panose="020B0604020202020204" pitchFamily="34" charset="0"/>
                        </a:rPr>
                        <a:t>TASK6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FFFFF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 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F2F2F2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>
                      <a:noFill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x-none" sz="1100" b="1" i="0" u="none" strike="noStrike" dirty="0">
                          <a:solidFill>
                            <a:srgbClr val="000000"/>
                          </a:solidFill>
                          <a:effectLst/>
                          <a:latin typeface="Calibri" panose="020F0502020204030204" pitchFamily="34" charset="0"/>
                        </a:rPr>
                        <a:t>100</a:t>
                      </a:r>
                    </a:p>
                  </a:txBody>
                  <a:tcPr marL="8585" marR="8585" marT="8585" marB="0" anchor="b">
                    <a:lnL>
                      <a:noFill/>
                    </a:lnL>
                    <a:lnR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R>
                    <a:lnT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T>
                    <a:lnB w="12700" cap="flat" cmpd="sng" algn="ctr">
                      <a:solidFill>
                        <a:srgbClr val="000000"/>
                      </a:solidFill>
                      <a:prstDash val="solid"/>
                      <a:round/>
                      <a:headEnd type="none" w="med" len="med"/>
                      <a:tailEnd type="none" w="med" len="med"/>
                    </a:lnB>
                    <a:solidFill>
                      <a:srgbClr val="0070C0"/>
                    </a:solidFill>
                  </a:tcPr>
                </a:tc>
                <a:extLst>
                  <a:ext uri="{0D108BD9-81ED-4DB2-BD59-A6C34878D82A}">
                    <a16:rowId xmlns:a16="http://schemas.microsoft.com/office/drawing/2014/main" val="3324642189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4227427742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Tabella 2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64180349"/>
              </p:ext>
            </p:extLst>
          </p:nvPr>
        </p:nvGraphicFramePr>
        <p:xfrm>
          <a:off x="242712" y="555974"/>
          <a:ext cx="8658576" cy="5737757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1394177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7264399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</a:tblGrid>
              <a:tr h="0"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3366"/>
                          </a:solidFill>
                          <a:effectLst/>
                          <a:latin typeface="Calibri" panose="020F0502020204030204" pitchFamily="34" charset="0"/>
                        </a:rPr>
                        <a:t>Reference</a:t>
                      </a:r>
                    </a:p>
                  </a:txBody>
                  <a:tcPr marL="2863" marR="2863" marT="2863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en-US" sz="1600" b="1" i="0" u="none" strike="noStrike" dirty="0">
                          <a:solidFill>
                            <a:srgbClr val="003366"/>
                          </a:solidFill>
                          <a:effectLst/>
                          <a:latin typeface="Calibri" panose="020F0502020204030204" pitchFamily="34" charset="0"/>
                        </a:rPr>
                        <a:t> Title</a:t>
                      </a:r>
                    </a:p>
                  </a:txBody>
                  <a:tcPr marL="2863" marR="2863" marT="2863" marB="0"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413579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it-IT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Drandi D et al.</a:t>
                      </a: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  <a:hlinkClick r:id="rId2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.</a:t>
                      </a:r>
                      <a:r>
                        <a:rPr lang="it-IT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 </a:t>
                      </a:r>
                      <a:r>
                        <a:rPr lang="it-IT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Hemasphere</a:t>
                      </a:r>
                      <a:r>
                        <a:rPr lang="it-IT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. 2020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  <a:hlinkClick r:id="rId2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Droplet Digital PCR Quantification of Mantle Cell Lymphoma Follow-up Samples From Four Prospective Trials of the European MCL Network</a:t>
                      </a:r>
                      <a:endParaRPr lang="en-GB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3528588114"/>
                  </a:ext>
                </a:extLst>
              </a:tr>
              <a:tr h="439251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Della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Starza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I et al.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Hematol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Oncol. 2020 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  <a:hlinkClick r:id="rId3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Immunoglobulin kappa deleting element rearrangements are candidate targets for minimal residual disease evaluation in mantle cell lymphoma</a:t>
                      </a:r>
                      <a:endParaRPr lang="en-GB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667060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Federico M. et al      15-ICML Lugano, Switzerland–June 18‐22, 2019.  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Response oriented maintenance therapy in advanced follicular lymphoma. results of the interim analysis of the foll12 trial conducted by the 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fondazione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 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italiana</a:t>
                      </a:r>
                      <a:r>
                        <a:rPr lang="en-US" sz="1000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 </a:t>
                      </a:r>
                      <a:r>
                        <a:rPr lang="en-US" sz="1000" kern="1200" dirty="0" err="1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linfomi</a:t>
                      </a:r>
                      <a:endParaRPr lang="en-IT" sz="1000" kern="1200" dirty="0">
                        <a:solidFill>
                          <a:srgbClr val="000000"/>
                        </a:solidFill>
                        <a:latin typeface="+mn-lt"/>
                        <a:ea typeface="NSimSun" panose="02010609030101010101" pitchFamily="49" charset="-122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1105768979"/>
                  </a:ext>
                </a:extLst>
              </a:tr>
              <a:tr h="530578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Alessandro </a:t>
                      </a:r>
                      <a:r>
                        <a:rPr lang="en-US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Pulsoni</a:t>
                      </a: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,</a:t>
                      </a:r>
                    </a:p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ASH 2019 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kern="1200" dirty="0">
                          <a:solidFill>
                            <a:srgbClr val="000000"/>
                          </a:solidFill>
                          <a:latin typeface="+mn-lt"/>
                          <a:ea typeface="Times New Roman" panose="02020603050405020304" pitchFamily="18" charset="0"/>
                          <a:cs typeface="+mn-cs"/>
                        </a:rPr>
                        <a:t>EARLY STAGE Follicular Lymphoma: First Results of the FIL "Miro" Study, a Multicenter Phase II Trial Combining Local Radiotherapy and MRD-Driven Immunotherapy</a:t>
                      </a:r>
                      <a:endParaRPr lang="en-IT" sz="1000" kern="1200" dirty="0">
                        <a:solidFill>
                          <a:srgbClr val="000000"/>
                        </a:solidFill>
                        <a:latin typeface="+mn-lt"/>
                        <a:ea typeface="Calibri" panose="020F0502020204030204" pitchFamily="34" charset="0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2412656869"/>
                  </a:ext>
                </a:extLst>
              </a:tr>
              <a:tr h="635864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Della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Starza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I et al.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Hematol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Oncol. 2019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  <a:hlinkClick r:id="rId4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Minimal residual disease (MRD) in non-Hodgkin lymphomas: Interlaboratory reproducibility on marrow samples with very low levels of disease within the FIL (Fondazione Italiana Linfomi) MRD Network</a:t>
                      </a:r>
                      <a:endParaRPr lang="en-GB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447870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i="0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Galimberti</a:t>
                      </a:r>
                      <a:r>
                        <a:rPr lang="en-GB" sz="1000" b="1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 et al Front Oncol. 2019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0" i="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  <a:hlinkClick r:id="rId5"/>
                        </a:rPr>
                        <a:t>The Minimal Residual Disease in Non-Hodgkin's Lymphomas: From the Laboratory to the Clinical Practice.</a:t>
                      </a:r>
                      <a:r>
                        <a:rPr lang="en-GB" sz="1000" b="0" i="0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, </a:t>
                      </a:r>
                    </a:p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GB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3922664903"/>
                  </a:ext>
                </a:extLst>
              </a:tr>
              <a:tr h="606536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Genuardi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E et al            Int J Lab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Hematol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. 2018 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  <a:hlinkClick r:id="rId6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Ficoll-hypaque separation vs whole blood lysis: Comparison of efficiency and impact on minimal residual disease analysis</a:t>
                      </a:r>
                      <a:endParaRPr lang="en-GB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  <a:tr h="563109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Mannu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C et al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Leuk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Lymphoma. 2016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  <a:hlinkClick r:id="rId7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Comparison of different DNA extraction methods from peripheral blood cells: advice from the Fondazione Italiana Linfomi Minimal Residual Disease Network.</a:t>
                      </a: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</a:t>
                      </a:r>
                    </a:p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10005"/>
                  </a:ext>
                </a:extLst>
              </a:tr>
              <a:tr h="604578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Della 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Starza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I et al .</a:t>
                      </a:r>
                      <a:r>
                        <a:rPr lang="en-GB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Hematol</a:t>
                      </a:r>
                      <a:r>
                        <a:rPr lang="en-GB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Oncol. 2014</a:t>
                      </a:r>
                      <a:endParaRPr lang="en-US" sz="1000" b="1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  <a:hlinkClick r:id="rId8">
                            <a:extLst>
                              <a:ext uri="{A12FA001-AC4F-418D-AE19-62706E023703}">
                                <ahyp:hlinkClr xmlns:ahyp="http://schemas.microsoft.com/office/drawing/2018/hyperlinkcolor" val="tx"/>
                              </a:ext>
                            </a:extLst>
                          </a:hlinkClick>
                        </a:rPr>
                        <a:t>Comparison of two real-time quantitative polymerase chain reaction strategies for minimal residual disease evaluation in lymphoproliferative disorders: correlation between immunoglobulin gene mutation load and real-time quantitative polymerase chain reaction performance.</a:t>
                      </a:r>
                      <a:endParaRPr lang="en-GB" sz="1000" kern="1200" dirty="0">
                        <a:solidFill>
                          <a:srgbClr val="000000"/>
                        </a:solidFill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2358619009"/>
                  </a:ext>
                </a:extLst>
              </a:tr>
              <a:tr h="582629">
                <a:tc>
                  <a:txBody>
                    <a:bodyPr/>
                    <a:lstStyle/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 err="1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Galimberti</a:t>
                      </a: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 et al </a:t>
                      </a:r>
                    </a:p>
                    <a:p>
                      <a:pPr marL="0" marR="0" lvl="1" indent="-45720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1000" b="1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2014</a:t>
                      </a:r>
                    </a:p>
                  </a:txBody>
                  <a:tcPr marL="2863" marR="2863" marT="0" marB="0" anchor="ctr"/>
                </a:tc>
                <a:tc>
                  <a:txBody>
                    <a:bodyPr/>
                    <a:lstStyle/>
                    <a:p>
                      <a:pPr marL="0" marR="0" lvl="2" indent="0" algn="ctr" defTabSz="914400" rtl="0" eaLnBrk="1" fontAlgn="auto" latinLnBrk="0" hangingPunct="1">
                        <a:lnSpc>
                          <a:spcPts val="1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1000" kern="1200" dirty="0">
                          <a:solidFill>
                            <a:srgbClr val="000000"/>
                          </a:solidFill>
                          <a:latin typeface="+mn-lt"/>
                          <a:ea typeface="+mn-ea"/>
                          <a:cs typeface="+mn-cs"/>
                        </a:rPr>
                        <a:t>Minimal residual disease after conventional treatment significantly impacts on progression-free survival of patients with follicular lymphoma: the FIL FOLL05 trial</a:t>
                      </a:r>
                    </a:p>
                  </a:txBody>
                  <a:tcPr marL="2863" marR="2863" marT="180000" marB="0"/>
                </a:tc>
                <a:extLst>
                  <a:ext uri="{0D108BD9-81ED-4DB2-BD59-A6C34878D82A}">
                    <a16:rowId xmlns:a16="http://schemas.microsoft.com/office/drawing/2014/main" val="10006"/>
                  </a:ext>
                </a:extLst>
              </a:tr>
            </a:tbl>
          </a:graphicData>
        </a:graphic>
      </p:graphicFrame>
      <p:sp>
        <p:nvSpPr>
          <p:cNvPr id="4" name="CasellaDiTesto 2">
            <a:extLst>
              <a:ext uri="{FF2B5EF4-FFF2-40B4-BE49-F238E27FC236}">
                <a16:creationId xmlns:a16="http://schemas.microsoft.com/office/drawing/2014/main" id="{325DFFFC-543E-5748-ACC4-7C63303DFA67}"/>
              </a:ext>
            </a:extLst>
          </p:cNvPr>
          <p:cNvSpPr txBox="1"/>
          <p:nvPr/>
        </p:nvSpPr>
        <p:spPr>
          <a:xfrm>
            <a:off x="242712" y="6404000"/>
            <a:ext cx="8623771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/>
              <a:t>SDC Table </a:t>
            </a:r>
            <a:r>
              <a:rPr lang="en-US" sz="1600" dirty="0"/>
              <a:t>5S. list of the publications generated in the context of the activities of the FIL MRD network </a:t>
            </a:r>
          </a:p>
        </p:txBody>
      </p:sp>
    </p:spTree>
    <p:extLst>
      <p:ext uri="{BB962C8B-B14F-4D97-AF65-F5344CB8AC3E}">
        <p14:creationId xmlns:p14="http://schemas.microsoft.com/office/powerpoint/2010/main" val="321392768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Tema di 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Tema di 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Tema di 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6734</TotalTime>
  <Words>1039</Words>
  <Application>Microsoft Macintosh PowerPoint</Application>
  <PresentationFormat>On-screen Show (4:3)</PresentationFormat>
  <Paragraphs>263</Paragraphs>
  <Slides>6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Arial</vt:lpstr>
      <vt:lpstr>Calibri</vt:lpstr>
      <vt:lpstr>Calibri Light</vt:lpstr>
      <vt:lpstr>Tema di Offic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Daniela Drandi</dc:creator>
  <cp:lastModifiedBy>Daniela Drandi</cp:lastModifiedBy>
  <cp:revision>92</cp:revision>
  <dcterms:created xsi:type="dcterms:W3CDTF">2020-11-16T13:26:06Z</dcterms:created>
  <dcterms:modified xsi:type="dcterms:W3CDTF">2021-04-09T10:26:41Z</dcterms:modified>
</cp:coreProperties>
</file>